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CE38269-FA1E-48B4-8C11-EDD8941F266C}" v="6" dt="2023-07-27T13:27:38.50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1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isco" userId="0590067e-ac7f-4ff1-aa46-83be6720f846" providerId="ADAL" clId="{3CE38269-FA1E-48B4-8C11-EDD8941F266C}"/>
    <pc:docChg chg="modSld">
      <pc:chgData name="Francisco" userId="0590067e-ac7f-4ff1-aa46-83be6720f846" providerId="ADAL" clId="{3CE38269-FA1E-48B4-8C11-EDD8941F266C}" dt="2023-07-27T13:27:41.699" v="11" actId="1076"/>
      <pc:docMkLst>
        <pc:docMk/>
      </pc:docMkLst>
      <pc:sldChg chg="addSp modSp mod">
        <pc:chgData name="Francisco" userId="0590067e-ac7f-4ff1-aa46-83be6720f846" providerId="ADAL" clId="{3CE38269-FA1E-48B4-8C11-EDD8941F266C}" dt="2023-07-27T13:24:46.470" v="1" actId="1076"/>
        <pc:sldMkLst>
          <pc:docMk/>
          <pc:sldMk cId="299022292" sldId="258"/>
        </pc:sldMkLst>
        <pc:spChg chg="add mod">
          <ac:chgData name="Francisco" userId="0590067e-ac7f-4ff1-aa46-83be6720f846" providerId="ADAL" clId="{3CE38269-FA1E-48B4-8C11-EDD8941F266C}" dt="2023-07-27T13:24:46.470" v="1" actId="1076"/>
          <ac:spMkLst>
            <pc:docMk/>
            <pc:sldMk cId="299022292" sldId="258"/>
            <ac:spMk id="2" creationId="{31572F38-03B3-64BC-5707-250FF4FB0EE0}"/>
          </ac:spMkLst>
        </pc:spChg>
      </pc:sldChg>
      <pc:sldChg chg="addSp modSp mod">
        <pc:chgData name="Francisco" userId="0590067e-ac7f-4ff1-aa46-83be6720f846" providerId="ADAL" clId="{3CE38269-FA1E-48B4-8C11-EDD8941F266C}" dt="2023-07-27T13:24:53.256" v="3" actId="1076"/>
        <pc:sldMkLst>
          <pc:docMk/>
          <pc:sldMk cId="2263296605" sldId="259"/>
        </pc:sldMkLst>
        <pc:spChg chg="add mod">
          <ac:chgData name="Francisco" userId="0590067e-ac7f-4ff1-aa46-83be6720f846" providerId="ADAL" clId="{3CE38269-FA1E-48B4-8C11-EDD8941F266C}" dt="2023-07-27T13:24:53.256" v="3" actId="1076"/>
          <ac:spMkLst>
            <pc:docMk/>
            <pc:sldMk cId="2263296605" sldId="259"/>
            <ac:spMk id="2" creationId="{57870589-83E2-2E71-259C-D98FF348A340}"/>
          </ac:spMkLst>
        </pc:spChg>
      </pc:sldChg>
      <pc:sldChg chg="addSp modSp mod">
        <pc:chgData name="Francisco" userId="0590067e-ac7f-4ff1-aa46-83be6720f846" providerId="ADAL" clId="{3CE38269-FA1E-48B4-8C11-EDD8941F266C}" dt="2023-07-27T13:25:00.977" v="5" actId="1076"/>
        <pc:sldMkLst>
          <pc:docMk/>
          <pc:sldMk cId="277944758" sldId="260"/>
        </pc:sldMkLst>
        <pc:spChg chg="add mod">
          <ac:chgData name="Francisco" userId="0590067e-ac7f-4ff1-aa46-83be6720f846" providerId="ADAL" clId="{3CE38269-FA1E-48B4-8C11-EDD8941F266C}" dt="2023-07-27T13:25:00.977" v="5" actId="1076"/>
          <ac:spMkLst>
            <pc:docMk/>
            <pc:sldMk cId="277944758" sldId="260"/>
            <ac:spMk id="2" creationId="{728A958B-3DE0-1621-6E87-70C3263451B0}"/>
          </ac:spMkLst>
        </pc:spChg>
      </pc:sldChg>
      <pc:sldChg chg="addSp modSp mod">
        <pc:chgData name="Francisco" userId="0590067e-ac7f-4ff1-aa46-83be6720f846" providerId="ADAL" clId="{3CE38269-FA1E-48B4-8C11-EDD8941F266C}" dt="2023-07-27T13:25:07.903" v="7" actId="1076"/>
        <pc:sldMkLst>
          <pc:docMk/>
          <pc:sldMk cId="1021793443" sldId="261"/>
        </pc:sldMkLst>
        <pc:spChg chg="add mod">
          <ac:chgData name="Francisco" userId="0590067e-ac7f-4ff1-aa46-83be6720f846" providerId="ADAL" clId="{3CE38269-FA1E-48B4-8C11-EDD8941F266C}" dt="2023-07-27T13:25:07.903" v="7" actId="1076"/>
          <ac:spMkLst>
            <pc:docMk/>
            <pc:sldMk cId="1021793443" sldId="261"/>
            <ac:spMk id="4" creationId="{97268FB7-DB97-0AC5-C416-C505894FF205}"/>
          </ac:spMkLst>
        </pc:spChg>
      </pc:sldChg>
      <pc:sldChg chg="addSp modSp mod">
        <pc:chgData name="Francisco" userId="0590067e-ac7f-4ff1-aa46-83be6720f846" providerId="ADAL" clId="{3CE38269-FA1E-48B4-8C11-EDD8941F266C}" dt="2023-07-27T13:27:35.884" v="9" actId="1076"/>
        <pc:sldMkLst>
          <pc:docMk/>
          <pc:sldMk cId="1079129519" sldId="262"/>
        </pc:sldMkLst>
        <pc:spChg chg="add mod">
          <ac:chgData name="Francisco" userId="0590067e-ac7f-4ff1-aa46-83be6720f846" providerId="ADAL" clId="{3CE38269-FA1E-48B4-8C11-EDD8941F266C}" dt="2023-07-27T13:27:35.884" v="9" actId="1076"/>
          <ac:spMkLst>
            <pc:docMk/>
            <pc:sldMk cId="1079129519" sldId="262"/>
            <ac:spMk id="2" creationId="{D50284F2-778F-0730-F666-9A43B0152495}"/>
          </ac:spMkLst>
        </pc:spChg>
      </pc:sldChg>
      <pc:sldChg chg="addSp modSp mod">
        <pc:chgData name="Francisco" userId="0590067e-ac7f-4ff1-aa46-83be6720f846" providerId="ADAL" clId="{3CE38269-FA1E-48B4-8C11-EDD8941F266C}" dt="2023-07-27T13:27:41.699" v="11" actId="1076"/>
        <pc:sldMkLst>
          <pc:docMk/>
          <pc:sldMk cId="1808728053" sldId="263"/>
        </pc:sldMkLst>
        <pc:spChg chg="add mod">
          <ac:chgData name="Francisco" userId="0590067e-ac7f-4ff1-aa46-83be6720f846" providerId="ADAL" clId="{3CE38269-FA1E-48B4-8C11-EDD8941F266C}" dt="2023-07-27T13:27:41.699" v="11" actId="1076"/>
          <ac:spMkLst>
            <pc:docMk/>
            <pc:sldMk cId="1808728053" sldId="263"/>
            <ac:spMk id="2" creationId="{BF46C204-DA98-64A3-7F0E-A94BBA0BFFFE}"/>
          </ac:spMkLst>
        </pc:spChg>
      </pc:sldChg>
    </pc:docChg>
  </pc:docChgLst>
  <pc:docChgLst>
    <pc:chgData name="Francisco" userId="0590067e-ac7f-4ff1-aa46-83be6720f846" providerId="ADAL" clId="{F50C9F16-162F-4A81-8678-FC98B4C494EC}"/>
    <pc:docChg chg="modSld">
      <pc:chgData name="Francisco" userId="0590067e-ac7f-4ff1-aa46-83be6720f846" providerId="ADAL" clId="{F50C9F16-162F-4A81-8678-FC98B4C494EC}" dt="2023-07-19T12:46:15.370" v="14" actId="20577"/>
      <pc:docMkLst>
        <pc:docMk/>
      </pc:docMkLst>
      <pc:sldChg chg="modSp mod">
        <pc:chgData name="Francisco" userId="0590067e-ac7f-4ff1-aa46-83be6720f846" providerId="ADAL" clId="{F50C9F16-162F-4A81-8678-FC98B4C494EC}" dt="2023-07-19T12:46:15.370" v="14" actId="20577"/>
        <pc:sldMkLst>
          <pc:docMk/>
          <pc:sldMk cId="4261239727" sldId="257"/>
        </pc:sldMkLst>
        <pc:spChg chg="mod">
          <ac:chgData name="Francisco" userId="0590067e-ac7f-4ff1-aa46-83be6720f846" providerId="ADAL" clId="{F50C9F16-162F-4A81-8678-FC98B4C494EC}" dt="2023-07-19T12:46:15.370" v="14" actId="20577"/>
          <ac:spMkLst>
            <pc:docMk/>
            <pc:sldMk cId="4261239727" sldId="257"/>
            <ac:spMk id="3" creationId="{D48C34A1-84AB-401E-C754-7B73379421E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DC64A3-04A4-418D-B670-B5A88DA79D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608C6AA-0C38-C713-F7BF-1042ED2C8F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s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6C93F1-53D0-0422-F5F8-F9BFE685E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97D067-E90C-62DE-6019-AAD57447A7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5F9E2F-C75A-26CC-7DFE-86090219D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4300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5DFC29-9E9A-7566-F4AD-ED52AF9FA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172DA6-690B-4B6F-A8CB-82CF0DF4E4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A27BD5-2ED7-B9E9-7542-A6C5341E2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160741-B4E7-0CC6-6DAD-5374830CA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6430D7-B1BF-1E6D-E9BD-901C27F01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255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768057-B2AF-16DD-B6FF-B49DDCABF0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88A30C-4FBE-F146-692A-56DCCC0BB6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D5D20F-D9BF-30DF-3EEF-DC2FBE028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CCA026-3D8C-CA29-7D69-9373327B5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B4E877-9696-BCE1-35C5-19694D692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8382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50E9C-69D4-CD28-F937-58D06B2A0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661BCA-8113-ADC2-7103-D319581F89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0F251D-2079-FB07-E7EA-6CDE5208DC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B9DB7E-A8E7-CE83-F0B8-FC08EA4D5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86B84D-0C21-5D90-DEB8-D4C98CD0F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4333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9BBB3-4594-F712-169A-0C3165D55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9CC29D-DA28-CC47-39A9-4119FE5CBF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879619-D8A7-D006-E62E-A4213003F8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CF9C93-8BD0-A78D-21AB-373558B27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E73901-47B4-F2C3-C605-239A81692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6947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91EB2-75E5-3B05-D390-5EB68381FF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A3812-374C-2B7C-7B8F-8B3E071EF1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4B843E-FCF8-321E-5309-D8701400C8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04F4A5-045D-DD64-6506-BABE2FA18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9BE24F-7BC3-9C69-CB63-6176A81D6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7A6015-73B0-1DBF-6236-332CF09B2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5070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5F55EC-D256-406A-BB82-0B8333DFC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68CA5B-4F62-2BE5-4C91-367B6AB523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18E90C-CE0E-430E-8006-01F6F826F2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26837C-3479-D41A-BBFC-DD6978423B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92F7F8-5B71-9193-791F-CD3F316FBA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C8C202-2D3E-0DE7-ADA0-97B31DE85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A97D8C-0C92-0E2D-B394-25C1203C4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86D2B0-83E8-68A3-7E34-C2AD6A4FA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4582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AFA848-2DD5-45D8-4E19-0B571E768B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1EEFBD-1BB3-0589-7407-4988D5440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B765089-8025-F7D9-13CA-6BE5A4B67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15D752-D06A-4905-5A2B-C04C3EADF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5299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63AB11-8D0A-99EF-9B72-F85C23019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816EF4A-D2BA-BE7E-0750-C87592B9D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166EEE-4FC6-E60F-ABAC-64E2762E3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4453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DE532E-EAED-6880-4B7C-B57A3CEB62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0E55A3-62D1-EE0F-682B-0C584D8322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E0D56A-63D8-5346-C799-6B74C3648A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F28C5E-519C-08BA-6C7E-8055A177E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7CF8A8-9FA1-1579-176E-78E575288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429D07-4231-0055-737F-C4F9BC8AD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0939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D12233-364B-90EE-D762-AE62326E73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0BEFA9-2862-28A5-0650-35EC4DADB0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BB3D04-F512-14C7-0037-C123A997B6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3C1AB3-54DD-6633-DB3B-AD0932858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FEEC2C-4313-4388-7E1C-ADC9B2134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10CB44-CC61-2FD8-27F3-591ABE472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0270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5D570B-3387-AA21-E623-A136819689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s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2BCD9D-59A0-46CE-8912-A32AEF2109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E42BC9-A37F-1A71-436A-37BE0EB51D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08CDCC-04DE-4424-BD48-2DC9D8177DAE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1E9C84-941E-05C4-89DF-1E0C9162E9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A17235-0330-1F1A-A816-E9D32F0FF9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FE058-FCCD-4D4C-9EF7-2630692958C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4330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13EE919-3999-F181-0955-53E765C0CC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1203"/>
          <a:stretch/>
        </p:blipFill>
        <p:spPr>
          <a:xfrm>
            <a:off x="681213" y="2041598"/>
            <a:ext cx="10829573" cy="199917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FFCAD8B-196E-F27C-48AC-3221B573A291}"/>
              </a:ext>
            </a:extLst>
          </p:cNvPr>
          <p:cNvSpPr txBox="1"/>
          <p:nvPr/>
        </p:nvSpPr>
        <p:spPr>
          <a:xfrm>
            <a:off x="235132" y="173315"/>
            <a:ext cx="1175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1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48C34A1-84AB-401E-C754-7B73379421E0}"/>
              </a:ext>
            </a:extLst>
          </p:cNvPr>
          <p:cNvSpPr txBox="1"/>
          <p:nvPr/>
        </p:nvSpPr>
        <p:spPr>
          <a:xfrm>
            <a:off x="590718" y="4040777"/>
            <a:ext cx="444506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onserved amino acids among LOXes proteins are resalted in red.</a:t>
            </a:r>
          </a:p>
          <a:p>
            <a:r>
              <a:rPr lang="en-GB" sz="1200" b="1" dirty="0"/>
              <a:t>Black point: denote mutations that appear in one sample</a:t>
            </a:r>
          </a:p>
          <a:p>
            <a:r>
              <a:rPr lang="en-GB" sz="1200" b="1" dirty="0"/>
              <a:t>Green point: denote mutation that appear in two different samples</a:t>
            </a:r>
          </a:p>
          <a:p>
            <a:r>
              <a:rPr lang="en-GB" sz="1200" b="1" dirty="0"/>
              <a:t>Red point: denote mutation that appear in three different samples</a:t>
            </a:r>
          </a:p>
          <a:p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4261239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>
            <a:extLst>
              <a:ext uri="{FF2B5EF4-FFF2-40B4-BE49-F238E27FC236}">
                <a16:creationId xmlns:a16="http://schemas.microsoft.com/office/drawing/2014/main" id="{3E37513A-BC45-77E2-75B3-90324AF929C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992"/>
          <a:stretch/>
        </p:blipFill>
        <p:spPr>
          <a:xfrm>
            <a:off x="747003" y="1889761"/>
            <a:ext cx="11180373" cy="328313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603F0BFE-700C-FF61-1F3F-A588B8BDA002}"/>
              </a:ext>
            </a:extLst>
          </p:cNvPr>
          <p:cNvSpPr txBox="1"/>
          <p:nvPr/>
        </p:nvSpPr>
        <p:spPr>
          <a:xfrm>
            <a:off x="235132" y="173315"/>
            <a:ext cx="1167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1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1572F38-03B3-64BC-5707-250FF4FB0EE0}"/>
              </a:ext>
            </a:extLst>
          </p:cNvPr>
          <p:cNvSpPr txBox="1"/>
          <p:nvPr/>
        </p:nvSpPr>
        <p:spPr>
          <a:xfrm>
            <a:off x="679730" y="5172891"/>
            <a:ext cx="444506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onserved amino acids among LOXes proteins are resalted in red.</a:t>
            </a:r>
          </a:p>
          <a:p>
            <a:r>
              <a:rPr lang="en-GB" sz="1200" b="1" dirty="0"/>
              <a:t>Black point: denote mutations that appear in one sample</a:t>
            </a:r>
          </a:p>
          <a:p>
            <a:r>
              <a:rPr lang="en-GB" sz="1200" b="1" dirty="0"/>
              <a:t>Green point: denote mutation that appear in two different samples</a:t>
            </a:r>
          </a:p>
          <a:p>
            <a:r>
              <a:rPr lang="en-GB" sz="1200" b="1" dirty="0"/>
              <a:t>Red point: denote mutation that appear in three different samples</a:t>
            </a:r>
          </a:p>
          <a:p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990222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3C4ED8B-D079-CF81-825C-463C699388A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585"/>
          <a:stretch/>
        </p:blipFill>
        <p:spPr>
          <a:xfrm>
            <a:off x="88534" y="1750423"/>
            <a:ext cx="11904879" cy="341376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43DDEC2-7112-B79F-022D-2BB289120555}"/>
              </a:ext>
            </a:extLst>
          </p:cNvPr>
          <p:cNvSpPr txBox="1"/>
          <p:nvPr/>
        </p:nvSpPr>
        <p:spPr>
          <a:xfrm>
            <a:off x="235132" y="173315"/>
            <a:ext cx="1165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1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7870589-83E2-2E71-259C-D98FF348A340}"/>
              </a:ext>
            </a:extLst>
          </p:cNvPr>
          <p:cNvSpPr txBox="1"/>
          <p:nvPr/>
        </p:nvSpPr>
        <p:spPr>
          <a:xfrm>
            <a:off x="88534" y="5356296"/>
            <a:ext cx="444506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onserved amino acids among LOXes proteins are resalted in red.</a:t>
            </a:r>
          </a:p>
          <a:p>
            <a:r>
              <a:rPr lang="en-GB" sz="1200" b="1" dirty="0"/>
              <a:t>Black point: denote mutations that appear in one sample</a:t>
            </a:r>
          </a:p>
          <a:p>
            <a:r>
              <a:rPr lang="en-GB" sz="1200" b="1" dirty="0"/>
              <a:t>Green point: denote mutation that appear in two different samples</a:t>
            </a:r>
          </a:p>
          <a:p>
            <a:r>
              <a:rPr lang="en-GB" sz="1200" b="1" dirty="0"/>
              <a:t>Red point: denote mutation that appear in three different samples</a:t>
            </a:r>
          </a:p>
          <a:p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2632966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D7EC298-5BAB-28E9-83AB-602DE543F7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228" y="1497874"/>
            <a:ext cx="11878205" cy="384047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319FBDB-8B33-E0B4-D20E-A2C9CD4A8C67}"/>
              </a:ext>
            </a:extLst>
          </p:cNvPr>
          <p:cNvSpPr txBox="1"/>
          <p:nvPr/>
        </p:nvSpPr>
        <p:spPr>
          <a:xfrm>
            <a:off x="235132" y="173315"/>
            <a:ext cx="1185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1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28A958B-3DE0-1621-6E87-70C3263451B0}"/>
              </a:ext>
            </a:extLst>
          </p:cNvPr>
          <p:cNvSpPr txBox="1"/>
          <p:nvPr/>
        </p:nvSpPr>
        <p:spPr>
          <a:xfrm>
            <a:off x="299405" y="5448791"/>
            <a:ext cx="444506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onserved amino acids among LOXes proteins are resalted in red.</a:t>
            </a:r>
          </a:p>
          <a:p>
            <a:r>
              <a:rPr lang="en-GB" sz="1200" b="1" dirty="0"/>
              <a:t>Black point: denote mutations that appear in one sample</a:t>
            </a:r>
          </a:p>
          <a:p>
            <a:r>
              <a:rPr lang="en-GB" sz="1200" b="1" dirty="0"/>
              <a:t>Green point: denote mutation that appear in two different samples</a:t>
            </a:r>
          </a:p>
          <a:p>
            <a:r>
              <a:rPr lang="en-GB" sz="1200" b="1" dirty="0"/>
              <a:t>Red point: denote mutation that appear in three different samples</a:t>
            </a:r>
          </a:p>
          <a:p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779447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F271F3B-143C-5614-11CB-5D2B9CF4F98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00" r="4773"/>
          <a:stretch/>
        </p:blipFill>
        <p:spPr>
          <a:xfrm>
            <a:off x="12768" y="1590675"/>
            <a:ext cx="11949217" cy="36195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A381737-3194-669D-7EE6-761AEA2FD7C9}"/>
              </a:ext>
            </a:extLst>
          </p:cNvPr>
          <p:cNvSpPr txBox="1"/>
          <p:nvPr/>
        </p:nvSpPr>
        <p:spPr>
          <a:xfrm>
            <a:off x="235132" y="173315"/>
            <a:ext cx="1154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1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268FB7-DB97-0AC5-C416-C505894FF205}"/>
              </a:ext>
            </a:extLst>
          </p:cNvPr>
          <p:cNvSpPr txBox="1"/>
          <p:nvPr/>
        </p:nvSpPr>
        <p:spPr>
          <a:xfrm>
            <a:off x="97103" y="5335503"/>
            <a:ext cx="444506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onserved amino acids among LOXes proteins are resalted in red.</a:t>
            </a:r>
          </a:p>
          <a:p>
            <a:r>
              <a:rPr lang="en-GB" sz="1200" b="1" dirty="0"/>
              <a:t>Black point: denote mutations that appear in one sample</a:t>
            </a:r>
          </a:p>
          <a:p>
            <a:r>
              <a:rPr lang="en-GB" sz="1200" b="1" dirty="0"/>
              <a:t>Green point: denote mutation that appear in two different samples</a:t>
            </a:r>
          </a:p>
          <a:p>
            <a:r>
              <a:rPr lang="en-GB" sz="1200" b="1" dirty="0"/>
              <a:t>Red point: denote mutation that appear in three different samples</a:t>
            </a:r>
          </a:p>
          <a:p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0217934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194937D-8533-9452-2827-DBB6A215E5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59" r="600"/>
          <a:stretch/>
        </p:blipFill>
        <p:spPr>
          <a:xfrm>
            <a:off x="55496" y="2203269"/>
            <a:ext cx="12014741" cy="239485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D931E59-370F-33F0-3B1D-9E8D5B8DD672}"/>
              </a:ext>
            </a:extLst>
          </p:cNvPr>
          <p:cNvSpPr txBox="1"/>
          <p:nvPr/>
        </p:nvSpPr>
        <p:spPr>
          <a:xfrm>
            <a:off x="235132" y="173315"/>
            <a:ext cx="1148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1F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50284F2-778F-0730-F666-9A43B0152495}"/>
              </a:ext>
            </a:extLst>
          </p:cNvPr>
          <p:cNvSpPr txBox="1"/>
          <p:nvPr/>
        </p:nvSpPr>
        <p:spPr>
          <a:xfrm>
            <a:off x="55496" y="4671956"/>
            <a:ext cx="444506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onserved amino acids among LOXes proteins are resalted in red.</a:t>
            </a:r>
          </a:p>
          <a:p>
            <a:r>
              <a:rPr lang="en-GB" sz="1200" b="1" dirty="0"/>
              <a:t>Black point: denote mutations that appear in one sample</a:t>
            </a:r>
          </a:p>
          <a:p>
            <a:r>
              <a:rPr lang="en-GB" sz="1200" b="1" dirty="0"/>
              <a:t>Green point: denote mutation that appear in two different samples</a:t>
            </a:r>
          </a:p>
          <a:p>
            <a:r>
              <a:rPr lang="en-GB" sz="1200" b="1" dirty="0"/>
              <a:t>Red point: denote mutation that appear in three different samples</a:t>
            </a:r>
          </a:p>
          <a:p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0791295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D650B15-B5ED-B78C-A759-D35ADF89AC6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87"/>
          <a:stretch/>
        </p:blipFill>
        <p:spPr>
          <a:xfrm>
            <a:off x="1933684" y="2220686"/>
            <a:ext cx="7973224" cy="210747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F3940FC-C415-5C68-2E61-30883C0EABE3}"/>
              </a:ext>
            </a:extLst>
          </p:cNvPr>
          <p:cNvSpPr txBox="1"/>
          <p:nvPr/>
        </p:nvSpPr>
        <p:spPr>
          <a:xfrm>
            <a:off x="235132" y="173315"/>
            <a:ext cx="1188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1G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F46C204-DA98-64A3-7F0E-A94BBA0BFFFE}"/>
              </a:ext>
            </a:extLst>
          </p:cNvPr>
          <p:cNvSpPr txBox="1"/>
          <p:nvPr/>
        </p:nvSpPr>
        <p:spPr>
          <a:xfrm>
            <a:off x="1933684" y="4461563"/>
            <a:ext cx="444506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onserved amino acids among LOXes proteins are resalted in red.</a:t>
            </a:r>
          </a:p>
          <a:p>
            <a:r>
              <a:rPr lang="en-GB" sz="1200" b="1" dirty="0"/>
              <a:t>Black point: denote mutations that appear in one sample</a:t>
            </a:r>
          </a:p>
          <a:p>
            <a:r>
              <a:rPr lang="en-GB" sz="1200" b="1" dirty="0"/>
              <a:t>Green point: denote mutation that appear in two different samples</a:t>
            </a:r>
          </a:p>
          <a:p>
            <a:r>
              <a:rPr lang="en-GB" sz="1200" b="1" dirty="0"/>
              <a:t>Red point: denote mutation that appear in three different samples</a:t>
            </a:r>
          </a:p>
          <a:p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808728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15</Words>
  <Application>Microsoft Office PowerPoint</Application>
  <PresentationFormat>Widescreen</PresentationFormat>
  <Paragraphs>3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isco</dc:creator>
  <cp:lastModifiedBy>Francisco</cp:lastModifiedBy>
  <cp:revision>1</cp:revision>
  <dcterms:created xsi:type="dcterms:W3CDTF">2023-07-18T14:29:52Z</dcterms:created>
  <dcterms:modified xsi:type="dcterms:W3CDTF">2023-07-27T13:27:42Z</dcterms:modified>
</cp:coreProperties>
</file>